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59" r:id="rId3"/>
    <p:sldId id="260" r:id="rId4"/>
    <p:sldId id="257" r:id="rId5"/>
    <p:sldId id="258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4AC16B-0747-4020-90B7-78C6AFD52C43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5DE165-25D5-48B1-A9C2-F4CA62B44A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947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规则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5DE165-25D5-48B1-A9C2-F4CA62B44A0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12079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不规则或溃疡，差</a:t>
            </a:r>
            <a:r>
              <a:rPr lang="en-US" altLang="zh-CN" dirty="0"/>
              <a:t>1VA</a:t>
            </a:r>
            <a:r>
              <a:rPr lang="zh-CN" altLang="en-US" dirty="0"/>
              <a:t>不规则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5DE165-25D5-48B1-A9C2-F4CA62B44A0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07528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13 13.68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5DE165-25D5-48B1-A9C2-F4CA62B44A0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932061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zh-CN" altLang="en-US" dirty="0"/>
              <a:t>开口或分叉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5DE165-25D5-48B1-A9C2-F4CA62B44A09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76532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F88CA62-AE74-4147-BDF5-D8045AF11D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D7B2BCCD-D951-4437-9F2F-AFE69DE9A4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364A5EF-6349-40A6-8969-C5D53173D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945D0D5-5AD8-471E-97D6-9B0440DAE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1D311D8-9BB1-45BF-B160-D7AF2C104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6881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757D1D6-DC99-4888-8857-B5278F949D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887D2AF7-ACB3-4908-B428-566E8CCCB3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B053731-E472-4C13-AFBD-4597800E5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7738D89-6880-4F2B-88C7-80D030D0C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03F838A-1278-4392-AA5D-E9E58BF3D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743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C130D59-A2ED-46BF-84E6-11D61A4275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DF48EFC-1A79-4FA5-91F2-855A605827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F5039D5-A892-4266-B2A7-7F6A7C885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A52CF9E-C4E2-4D4C-AE78-1E21F9F2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07C04F0-6E47-4480-9B08-7756ED4EC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620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129A2C5-A018-4D9F-97C2-00EFFE3A02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97EF6FA6-CF38-4DFD-BA59-16F32AF1E7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13BBB36-3314-44B4-B847-62C9C5DF0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5468D3C4-6862-4141-950E-31491C29FE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2224A907-CB92-4C88-91A9-A2AC9251C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678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D0D8C51-BD17-4998-B858-40A72E02C2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19F123AA-407B-428B-8BB4-F1610E5DC5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273BFE5-782E-48F3-947B-F21C28044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DA9DA14-D10E-4204-8D60-459ED1BA8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A381C43-FDDC-41F3-B9F3-6EBF4DD293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312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E06E55D-B8A5-46E0-92B2-12EC777AD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9F188D6-D6E4-4DE5-8E16-22CDB434EA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0CB4663A-CC62-4DC4-BC70-E77C926386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1FC2C59-BBFD-4274-94F5-4DE31756F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15E46F9-4F99-44E3-99C5-EB11839E96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961B7231-001A-4FE9-A459-3F38E8868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2202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EEC38ED-4489-456C-AC57-55467BD571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4E195C91-6E3A-433F-A1CA-AB90B41A1C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C06BB949-5272-4EF9-9539-0C0AECB017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44FE1DE6-82CB-4832-8017-AD89EBA99C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CF76DCB2-E3F4-409E-8B10-EFFA29068E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FF230207-DBEC-4DBD-9022-D9A6230E7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0EEB9A71-A7F6-48D8-B788-34A3484D6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F5D27F95-6105-43A2-B0BA-5679FEB4C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9847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B76A1D0-2CB4-46D4-8A9B-66D592F8F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554C6BD-8162-4AA5-9672-513D6AB7D8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174C6C54-5A26-43BD-A72E-56B6F6676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0256F6BA-FE1F-4DC0-877D-7CFAE78B8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8841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00EF54D0-15C5-4273-B558-06BABF884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033C7B5-C67D-47C9-89F0-C44A54791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4164F989-D02D-485F-B6D4-E564A9C91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9288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544B6EB-D5C2-4D7E-8C67-2411379ABF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13F2069-540B-4A74-B204-8EC388F423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C282462A-F902-4E7F-A841-5CB991DCDF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07B45BE-928B-4FEE-BD56-A982925F3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65B9361B-D576-4C88-973B-1788257149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E6DD0FA5-3FAF-4D7D-8ABC-0E0AD4B8D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5168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813463C-B08C-4A2F-B7FF-58E3016234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2BECF7BC-C61D-49CE-80A6-3F573D26C4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1FDCF729-62F5-4872-A34E-46FC1BFC0C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D5D0434-8AAA-4DF2-9ECB-756908F0F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B5A526FE-CF27-4FB7-9036-9DF6E74EF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81611CCC-0AF6-4F97-B9E5-326624E2ED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1450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EA3BB941-2795-474B-9687-DB1C2B37DB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37830B9-B952-4125-A625-4C63C0AC58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B1CB580-AF6A-4B36-8028-604EC6AC3E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4D040-A0AD-4D8E-AB66-30C9F6F2D88F}" type="datetimeFigureOut">
              <a:rPr lang="zh-CN" altLang="en-US" smtClean="0"/>
              <a:t>2022/1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902B735-EB0D-4279-9CF1-1B355D102D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5A08592-3EC9-41C4-8C82-9C55DF15B6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60985-5CED-4CAA-ADC2-5E0E67C26E5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4819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g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g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g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4800" dirty="0" smtClean="0"/>
              <a:t>Illustration of supplement Figures</a:t>
            </a:r>
            <a:endParaRPr lang="zh-CN" altLang="en-US" sz="4800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30322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BFBFAFA7-0AB3-45D8-95F8-E4924239F045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78" t="26667" r="36666" b="12740"/>
          <a:stretch/>
        </p:blipFill>
        <p:spPr>
          <a:xfrm>
            <a:off x="4373563" y="152620"/>
            <a:ext cx="3315600" cy="32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632B501C-BCBC-41E3-A1BA-847DA510CC4D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592" t="33036" r="21556" b="1"/>
          <a:stretch/>
        </p:blipFill>
        <p:spPr>
          <a:xfrm>
            <a:off x="1057963" y="3392620"/>
            <a:ext cx="3315600" cy="32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A57D3DF1-8652-4BDA-8101-14894D294FB4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12" t="12592" r="47037" b="19112"/>
          <a:stretch/>
        </p:blipFill>
        <p:spPr>
          <a:xfrm>
            <a:off x="1057963" y="152620"/>
            <a:ext cx="3315600" cy="32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1646EC58-63F2-4A16-A501-1F4B7756A768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85" t="15704" r="32222" b="22815"/>
          <a:stretch/>
        </p:blipFill>
        <p:spPr>
          <a:xfrm>
            <a:off x="4373563" y="3392620"/>
            <a:ext cx="3315600" cy="3240000"/>
          </a:xfrm>
          <a:prstGeom prst="rect">
            <a:avLst/>
          </a:prstGeom>
        </p:spPr>
      </p:pic>
      <p:sp>
        <p:nvSpPr>
          <p:cNvPr id="13" name="箭头: 下 12">
            <a:extLst>
              <a:ext uri="{FF2B5EF4-FFF2-40B4-BE49-F238E27FC236}">
                <a16:creationId xmlns:a16="http://schemas.microsoft.com/office/drawing/2014/main" xmlns="" id="{78F6D057-2613-45ED-BDD4-AF95AD6E438D}"/>
              </a:ext>
            </a:extLst>
          </p:cNvPr>
          <p:cNvSpPr/>
          <p:nvPr/>
        </p:nvSpPr>
        <p:spPr>
          <a:xfrm rot="10263127">
            <a:off x="2452127" y="1782343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箭头: 下 13">
            <a:extLst>
              <a:ext uri="{FF2B5EF4-FFF2-40B4-BE49-F238E27FC236}">
                <a16:creationId xmlns:a16="http://schemas.microsoft.com/office/drawing/2014/main" xmlns="" id="{A5F30D7E-0E94-44FC-983E-5BE4F5C4D3EC}"/>
              </a:ext>
            </a:extLst>
          </p:cNvPr>
          <p:cNvSpPr/>
          <p:nvPr/>
        </p:nvSpPr>
        <p:spPr>
          <a:xfrm rot="11218936">
            <a:off x="3053783" y="5305047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xmlns="" id="{E08F39A7-49DC-4AB6-ACD1-574E49F3ABDE}"/>
              </a:ext>
            </a:extLst>
          </p:cNvPr>
          <p:cNvSpPr/>
          <p:nvPr/>
        </p:nvSpPr>
        <p:spPr>
          <a:xfrm rot="4092606">
            <a:off x="5111522" y="4210337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箭头: 下 15">
            <a:extLst>
              <a:ext uri="{FF2B5EF4-FFF2-40B4-BE49-F238E27FC236}">
                <a16:creationId xmlns:a16="http://schemas.microsoft.com/office/drawing/2014/main" xmlns="" id="{8FF84F09-CA7A-42F2-971C-E4D593648ACC}"/>
              </a:ext>
            </a:extLst>
          </p:cNvPr>
          <p:cNvSpPr/>
          <p:nvPr/>
        </p:nvSpPr>
        <p:spPr>
          <a:xfrm rot="2742820">
            <a:off x="6363526" y="1629935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4CDE3B5F-2124-440D-BE9F-29D63EAF9C0E}"/>
              </a:ext>
            </a:extLst>
          </p:cNvPr>
          <p:cNvSpPr txBox="1"/>
          <p:nvPr/>
        </p:nvSpPr>
        <p:spPr>
          <a:xfrm>
            <a:off x="1057963" y="286940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7D3AA32A-4B89-42E9-9E4C-F1C9EFD63B64}"/>
              </a:ext>
            </a:extLst>
          </p:cNvPr>
          <p:cNvSpPr txBox="1"/>
          <p:nvPr/>
        </p:nvSpPr>
        <p:spPr>
          <a:xfrm>
            <a:off x="1057963" y="610940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3CE93843-2273-4C2D-B03F-4E17043F9B30}"/>
              </a:ext>
            </a:extLst>
          </p:cNvPr>
          <p:cNvSpPr txBox="1"/>
          <p:nvPr/>
        </p:nvSpPr>
        <p:spPr>
          <a:xfrm>
            <a:off x="4373563" y="286940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C</a:t>
            </a:r>
            <a:endParaRPr lang="zh-CN" altLang="en-US" sz="28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2E0486F7-12D1-4A18-B07B-A7FACF4D15DE}"/>
              </a:ext>
            </a:extLst>
          </p:cNvPr>
          <p:cNvSpPr txBox="1"/>
          <p:nvPr/>
        </p:nvSpPr>
        <p:spPr>
          <a:xfrm>
            <a:off x="4346686" y="610940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D</a:t>
            </a:r>
            <a:endParaRPr lang="zh-CN" altLang="en-US" sz="28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031BE6E8-DCD2-4EC7-9608-CA1305AC431F}"/>
              </a:ext>
            </a:extLst>
          </p:cNvPr>
          <p:cNvSpPr txBox="1"/>
          <p:nvPr/>
        </p:nvSpPr>
        <p:spPr>
          <a:xfrm>
            <a:off x="7964998" y="504428"/>
            <a:ext cx="34120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 smtClean="0"/>
              <a:t>Supplement</a:t>
            </a:r>
          </a:p>
          <a:p>
            <a:r>
              <a:rPr lang="en-US" altLang="zh-CN" sz="4800" dirty="0" smtClean="0"/>
              <a:t>Figure </a:t>
            </a:r>
            <a:r>
              <a:rPr lang="en-US" altLang="zh-CN" sz="4800" dirty="0"/>
              <a:t>1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89931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59FBC686-06B0-4AC8-9BE5-B3CC92CCB06C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30" t="34147" r="222" b="638"/>
          <a:stretch/>
        </p:blipFill>
        <p:spPr>
          <a:xfrm>
            <a:off x="4663181" y="3429000"/>
            <a:ext cx="3315600" cy="32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CFEA5A9A-A1DE-456B-AA9C-1189A2EC4F6D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26223" r="37947" b="1798"/>
          <a:stretch/>
        </p:blipFill>
        <p:spPr>
          <a:xfrm>
            <a:off x="1361681" y="189000"/>
            <a:ext cx="3315600" cy="32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0D071896-2649-4E51-BE15-A6693FE1F310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17" t="22666" r="23186"/>
          <a:stretch/>
        </p:blipFill>
        <p:spPr>
          <a:xfrm>
            <a:off x="1347581" y="3429000"/>
            <a:ext cx="3315600" cy="3240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FD8FF572-9129-4302-9807-50324921627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04" t="24593" r="27852" b="20155"/>
          <a:stretch/>
        </p:blipFill>
        <p:spPr>
          <a:xfrm>
            <a:off x="4663181" y="189000"/>
            <a:ext cx="3315600" cy="3240000"/>
          </a:xfrm>
          <a:prstGeom prst="rect">
            <a:avLst/>
          </a:prstGeom>
        </p:spPr>
      </p:pic>
      <p:sp>
        <p:nvSpPr>
          <p:cNvPr id="12" name="箭头: 下 11">
            <a:extLst>
              <a:ext uri="{FF2B5EF4-FFF2-40B4-BE49-F238E27FC236}">
                <a16:creationId xmlns:a16="http://schemas.microsoft.com/office/drawing/2014/main" xmlns="" id="{046742FE-0907-42AE-9B67-4A0494FAE7EE}"/>
              </a:ext>
            </a:extLst>
          </p:cNvPr>
          <p:cNvSpPr/>
          <p:nvPr/>
        </p:nvSpPr>
        <p:spPr>
          <a:xfrm rot="9792227">
            <a:off x="2646739" y="2008928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箭头: 下 12">
            <a:extLst>
              <a:ext uri="{FF2B5EF4-FFF2-40B4-BE49-F238E27FC236}">
                <a16:creationId xmlns:a16="http://schemas.microsoft.com/office/drawing/2014/main" xmlns="" id="{10DD4EB6-BF25-4E70-9958-1D66E624C801}"/>
              </a:ext>
            </a:extLst>
          </p:cNvPr>
          <p:cNvSpPr/>
          <p:nvPr/>
        </p:nvSpPr>
        <p:spPr>
          <a:xfrm rot="20408421">
            <a:off x="3674891" y="4906316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箭头: 下 13">
            <a:extLst>
              <a:ext uri="{FF2B5EF4-FFF2-40B4-BE49-F238E27FC236}">
                <a16:creationId xmlns:a16="http://schemas.microsoft.com/office/drawing/2014/main" xmlns="" id="{E42E3574-C02F-4AB2-AEA9-2D7782A34437}"/>
              </a:ext>
            </a:extLst>
          </p:cNvPr>
          <p:cNvSpPr/>
          <p:nvPr/>
        </p:nvSpPr>
        <p:spPr>
          <a:xfrm rot="4934064">
            <a:off x="5629053" y="4386469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xmlns="" id="{D5F95082-86CC-4B35-8496-415D91E4495E}"/>
              </a:ext>
            </a:extLst>
          </p:cNvPr>
          <p:cNvSpPr/>
          <p:nvPr/>
        </p:nvSpPr>
        <p:spPr>
          <a:xfrm rot="4392299">
            <a:off x="6247300" y="2166683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93DE80BA-BA0D-4CC1-A718-A8D0C42F62EF}"/>
              </a:ext>
            </a:extLst>
          </p:cNvPr>
          <p:cNvSpPr txBox="1"/>
          <p:nvPr/>
        </p:nvSpPr>
        <p:spPr>
          <a:xfrm>
            <a:off x="1361681" y="290578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457588EB-FB37-415D-8DF8-650B2586D468}"/>
              </a:ext>
            </a:extLst>
          </p:cNvPr>
          <p:cNvSpPr txBox="1"/>
          <p:nvPr/>
        </p:nvSpPr>
        <p:spPr>
          <a:xfrm>
            <a:off x="1347581" y="616508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274AD3CB-4835-4EEA-9335-6D285E6F2A15}"/>
              </a:ext>
            </a:extLst>
          </p:cNvPr>
          <p:cNvSpPr txBox="1"/>
          <p:nvPr/>
        </p:nvSpPr>
        <p:spPr>
          <a:xfrm>
            <a:off x="4648672" y="290578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C</a:t>
            </a:r>
            <a:endParaRPr lang="zh-CN" altLang="en-US" sz="28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xmlns="" id="{991A8813-4548-414E-A13C-1F10BAE8368A}"/>
              </a:ext>
            </a:extLst>
          </p:cNvPr>
          <p:cNvSpPr txBox="1"/>
          <p:nvPr/>
        </p:nvSpPr>
        <p:spPr>
          <a:xfrm>
            <a:off x="4648672" y="614578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D</a:t>
            </a:r>
            <a:endParaRPr lang="zh-CN" altLang="en-US" sz="28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xmlns="" id="{60599420-841D-4413-950A-6096827DA2CF}"/>
              </a:ext>
            </a:extLst>
          </p:cNvPr>
          <p:cNvSpPr txBox="1"/>
          <p:nvPr/>
        </p:nvSpPr>
        <p:spPr>
          <a:xfrm>
            <a:off x="8150560" y="402828"/>
            <a:ext cx="35248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 smtClean="0"/>
              <a:t>Supplement</a:t>
            </a:r>
            <a:endParaRPr lang="en-US" altLang="zh-CN" sz="4800" dirty="0" smtClean="0"/>
          </a:p>
          <a:p>
            <a:r>
              <a:rPr lang="en-US" altLang="zh-CN" sz="4800" dirty="0" smtClean="0"/>
              <a:t>Figure </a:t>
            </a:r>
            <a:r>
              <a:rPr lang="en-US" altLang="zh-CN" sz="4800" dirty="0"/>
              <a:t>2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28257805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37856449-93D4-4B0F-9B8E-C5AAB682F42F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19" t="35555" r="24815" b="9333"/>
          <a:stretch/>
        </p:blipFill>
        <p:spPr>
          <a:xfrm>
            <a:off x="4338947" y="3451808"/>
            <a:ext cx="3302791" cy="32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8CD015B4-C091-4992-AEC8-16CBE7BAB683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22" t="23259" r="34593" b="7408"/>
          <a:stretch/>
        </p:blipFill>
        <p:spPr>
          <a:xfrm>
            <a:off x="1022681" y="3451808"/>
            <a:ext cx="3316267" cy="32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8C3A07E2-42E2-412F-AB1C-183EB7C93570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66" t="2727" r="21402" b="16930"/>
          <a:stretch/>
        </p:blipFill>
        <p:spPr>
          <a:xfrm>
            <a:off x="4326138" y="211808"/>
            <a:ext cx="3315600" cy="32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043345C5-9F3F-42A3-9363-D1B8C1064988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15" t="32741" r="38148" b="10222"/>
          <a:stretch/>
        </p:blipFill>
        <p:spPr>
          <a:xfrm>
            <a:off x="1022681" y="211808"/>
            <a:ext cx="3316267" cy="3240000"/>
          </a:xfrm>
          <a:prstGeom prst="rect">
            <a:avLst/>
          </a:prstGeom>
        </p:spPr>
      </p:pic>
      <p:sp>
        <p:nvSpPr>
          <p:cNvPr id="3" name="箭头: 下 2">
            <a:extLst>
              <a:ext uri="{FF2B5EF4-FFF2-40B4-BE49-F238E27FC236}">
                <a16:creationId xmlns:a16="http://schemas.microsoft.com/office/drawing/2014/main" xmlns="" id="{AB641FC4-9E1E-495E-A6B4-5AEC163F2A8C}"/>
              </a:ext>
            </a:extLst>
          </p:cNvPr>
          <p:cNvSpPr/>
          <p:nvPr/>
        </p:nvSpPr>
        <p:spPr>
          <a:xfrm rot="9832452">
            <a:off x="2335232" y="1841082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箭头: 下 12">
            <a:extLst>
              <a:ext uri="{FF2B5EF4-FFF2-40B4-BE49-F238E27FC236}">
                <a16:creationId xmlns:a16="http://schemas.microsoft.com/office/drawing/2014/main" xmlns="" id="{0DB96D82-43C8-4DF9-954B-44D96F07BD8D}"/>
              </a:ext>
            </a:extLst>
          </p:cNvPr>
          <p:cNvSpPr/>
          <p:nvPr/>
        </p:nvSpPr>
        <p:spPr>
          <a:xfrm rot="9140637">
            <a:off x="2935642" y="5491850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箭头: 下 13">
            <a:extLst>
              <a:ext uri="{FF2B5EF4-FFF2-40B4-BE49-F238E27FC236}">
                <a16:creationId xmlns:a16="http://schemas.microsoft.com/office/drawing/2014/main" xmlns="" id="{4F6ACA32-CB94-47B9-9177-3409F2FDD1A8}"/>
              </a:ext>
            </a:extLst>
          </p:cNvPr>
          <p:cNvSpPr/>
          <p:nvPr/>
        </p:nvSpPr>
        <p:spPr>
          <a:xfrm rot="3157429">
            <a:off x="5899010" y="4457371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xmlns="" id="{161E5F0A-B4EE-4E50-A407-9C786F4D0106}"/>
              </a:ext>
            </a:extLst>
          </p:cNvPr>
          <p:cNvSpPr/>
          <p:nvPr/>
        </p:nvSpPr>
        <p:spPr>
          <a:xfrm rot="20839010">
            <a:off x="5903113" y="1629679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78B338C2-248D-4DA1-B659-8EB461FDC337}"/>
              </a:ext>
            </a:extLst>
          </p:cNvPr>
          <p:cNvSpPr txBox="1"/>
          <p:nvPr/>
        </p:nvSpPr>
        <p:spPr>
          <a:xfrm>
            <a:off x="1036157" y="292508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FF1A038B-C321-4FE6-AECE-4B3B893F8D5D}"/>
              </a:ext>
            </a:extLst>
          </p:cNvPr>
          <p:cNvSpPr txBox="1"/>
          <p:nvPr/>
        </p:nvSpPr>
        <p:spPr>
          <a:xfrm>
            <a:off x="1036157" y="6176708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7891E50D-946D-4A99-8044-1E92484DD16A}"/>
              </a:ext>
            </a:extLst>
          </p:cNvPr>
          <p:cNvSpPr txBox="1"/>
          <p:nvPr/>
        </p:nvSpPr>
        <p:spPr>
          <a:xfrm>
            <a:off x="4384905" y="2925100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C</a:t>
            </a:r>
            <a:endParaRPr lang="zh-CN" altLang="en-US" sz="28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C3DDE60E-97D4-4719-9A7C-7606F3B1AAD9}"/>
              </a:ext>
            </a:extLst>
          </p:cNvPr>
          <p:cNvSpPr txBox="1"/>
          <p:nvPr/>
        </p:nvSpPr>
        <p:spPr>
          <a:xfrm>
            <a:off x="4326138" y="6176424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D</a:t>
            </a:r>
            <a:endParaRPr lang="zh-CN" altLang="en-US" sz="2800" b="1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xmlns="" id="{01935AD7-C567-4F07-8E58-23C93DD2D96C}"/>
              </a:ext>
            </a:extLst>
          </p:cNvPr>
          <p:cNvSpPr txBox="1"/>
          <p:nvPr/>
        </p:nvSpPr>
        <p:spPr>
          <a:xfrm>
            <a:off x="7964998" y="504428"/>
            <a:ext cx="36911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/>
              <a:t>Supplement</a:t>
            </a:r>
          </a:p>
          <a:p>
            <a:r>
              <a:rPr lang="en-US" altLang="zh-CN" sz="4800" dirty="0" smtClean="0"/>
              <a:t>Figure </a:t>
            </a:r>
            <a:r>
              <a:rPr lang="en-US" altLang="zh-CN" sz="4800" dirty="0"/>
              <a:t>3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4038674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BC49E5FC-B3E9-402D-9D54-5573B4FFE296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26" t="22667" r="20371" b="15407"/>
          <a:stretch/>
        </p:blipFill>
        <p:spPr>
          <a:xfrm>
            <a:off x="1210746" y="266768"/>
            <a:ext cx="3315600" cy="32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7C36BB5E-7CB1-465D-BC81-D64CF3AD1DAC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30" t="19035" r="20074" b="12298"/>
          <a:stretch/>
        </p:blipFill>
        <p:spPr>
          <a:xfrm>
            <a:off x="1210746" y="3506768"/>
            <a:ext cx="3315600" cy="324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7E5EBA82-E3EF-409F-838D-F636844E0D00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97" t="20740" r="27407" b="13484"/>
          <a:stretch/>
        </p:blipFill>
        <p:spPr>
          <a:xfrm>
            <a:off x="4526346" y="3506768"/>
            <a:ext cx="3315600" cy="324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9F67FD1B-9A26-4A87-BBA2-F2C559BFBE4D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0" t="15704" r="37704" b="12147"/>
          <a:stretch/>
        </p:blipFill>
        <p:spPr>
          <a:xfrm>
            <a:off x="4526346" y="266768"/>
            <a:ext cx="3315600" cy="3240000"/>
          </a:xfrm>
          <a:prstGeom prst="rect">
            <a:avLst/>
          </a:prstGeom>
        </p:spPr>
      </p:pic>
      <p:sp>
        <p:nvSpPr>
          <p:cNvPr id="13" name="箭头: 下 12">
            <a:extLst>
              <a:ext uri="{FF2B5EF4-FFF2-40B4-BE49-F238E27FC236}">
                <a16:creationId xmlns:a16="http://schemas.microsoft.com/office/drawing/2014/main" xmlns="" id="{EC0B726C-E313-4771-8BBD-D4BA0E9C0FEE}"/>
              </a:ext>
            </a:extLst>
          </p:cNvPr>
          <p:cNvSpPr/>
          <p:nvPr/>
        </p:nvSpPr>
        <p:spPr>
          <a:xfrm rot="9359741">
            <a:off x="6448966" y="1368379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箭头: 下 13">
            <a:extLst>
              <a:ext uri="{FF2B5EF4-FFF2-40B4-BE49-F238E27FC236}">
                <a16:creationId xmlns:a16="http://schemas.microsoft.com/office/drawing/2014/main" xmlns="" id="{96407B30-4FD1-4878-8A0E-506B6100DA22}"/>
              </a:ext>
            </a:extLst>
          </p:cNvPr>
          <p:cNvSpPr/>
          <p:nvPr/>
        </p:nvSpPr>
        <p:spPr>
          <a:xfrm rot="20176309">
            <a:off x="2669997" y="1597575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箭头: 下 14">
            <a:extLst>
              <a:ext uri="{FF2B5EF4-FFF2-40B4-BE49-F238E27FC236}">
                <a16:creationId xmlns:a16="http://schemas.microsoft.com/office/drawing/2014/main" xmlns="" id="{F09C1E30-6D63-42CD-9ADB-2B4D6791F582}"/>
              </a:ext>
            </a:extLst>
          </p:cNvPr>
          <p:cNvSpPr/>
          <p:nvPr/>
        </p:nvSpPr>
        <p:spPr>
          <a:xfrm rot="14736073">
            <a:off x="5655742" y="3850971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箭头: 下 15">
            <a:extLst>
              <a:ext uri="{FF2B5EF4-FFF2-40B4-BE49-F238E27FC236}">
                <a16:creationId xmlns:a16="http://schemas.microsoft.com/office/drawing/2014/main" xmlns="" id="{DDF2F0B2-9E19-4BFF-A800-9BD9FF413AA9}"/>
              </a:ext>
            </a:extLst>
          </p:cNvPr>
          <p:cNvSpPr/>
          <p:nvPr/>
        </p:nvSpPr>
        <p:spPr>
          <a:xfrm rot="20015456">
            <a:off x="3059172" y="5130888"/>
            <a:ext cx="147363" cy="285366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xmlns="" id="{A6789F48-909B-4478-8E69-1A3935460562}"/>
              </a:ext>
            </a:extLst>
          </p:cNvPr>
          <p:cNvSpPr txBox="1"/>
          <p:nvPr/>
        </p:nvSpPr>
        <p:spPr>
          <a:xfrm>
            <a:off x="1210746" y="2983548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A</a:t>
            </a:r>
            <a:endParaRPr lang="zh-CN" altLang="en-US" sz="28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0D99ED2F-FF9D-436F-8FDA-BAB0FCD707C5}"/>
              </a:ext>
            </a:extLst>
          </p:cNvPr>
          <p:cNvSpPr txBox="1"/>
          <p:nvPr/>
        </p:nvSpPr>
        <p:spPr>
          <a:xfrm>
            <a:off x="1210746" y="6223548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B</a:t>
            </a:r>
            <a:endParaRPr lang="zh-CN" altLang="en-US" sz="28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xmlns="" id="{CF361686-B75E-4E64-821A-4FDA307FB55D}"/>
              </a:ext>
            </a:extLst>
          </p:cNvPr>
          <p:cNvSpPr txBox="1"/>
          <p:nvPr/>
        </p:nvSpPr>
        <p:spPr>
          <a:xfrm>
            <a:off x="4526346" y="2983548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C</a:t>
            </a:r>
            <a:endParaRPr lang="zh-CN" altLang="en-US" sz="28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xmlns="" id="{7FF8FB92-1919-48C1-AD1A-D28124460EA8}"/>
              </a:ext>
            </a:extLst>
          </p:cNvPr>
          <p:cNvSpPr txBox="1"/>
          <p:nvPr/>
        </p:nvSpPr>
        <p:spPr>
          <a:xfrm>
            <a:off x="4592452" y="6223548"/>
            <a:ext cx="721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/>
              <a:t>D</a:t>
            </a:r>
            <a:endParaRPr lang="zh-CN" altLang="en-US" sz="28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xmlns="" id="{FD8AB915-A197-4419-9F52-CAAA4582F3A9}"/>
              </a:ext>
            </a:extLst>
          </p:cNvPr>
          <p:cNvSpPr txBox="1"/>
          <p:nvPr/>
        </p:nvSpPr>
        <p:spPr>
          <a:xfrm>
            <a:off x="7964998" y="504428"/>
            <a:ext cx="387407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/>
              <a:t>Supplement</a:t>
            </a:r>
          </a:p>
          <a:p>
            <a:r>
              <a:rPr lang="en-US" altLang="zh-CN" sz="4800" dirty="0" smtClean="0"/>
              <a:t>Figure </a:t>
            </a:r>
            <a:r>
              <a:rPr lang="en-US" altLang="zh-CN" sz="4800" dirty="0"/>
              <a:t>4</a:t>
            </a:r>
            <a:endParaRPr lang="zh-CN" altLang="en-US" sz="4800" dirty="0"/>
          </a:p>
        </p:txBody>
      </p:sp>
    </p:spTree>
    <p:extLst>
      <p:ext uri="{BB962C8B-B14F-4D97-AF65-F5344CB8AC3E}">
        <p14:creationId xmlns:p14="http://schemas.microsoft.com/office/powerpoint/2010/main" val="1997380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1</TotalTime>
  <Words>49</Words>
  <Application>Microsoft Office PowerPoint</Application>
  <PresentationFormat>宽屏</PresentationFormat>
  <Paragraphs>33</Paragraphs>
  <Slides>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Illustration of supplement Figure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379244676@qq.com</dc:creator>
  <cp:lastModifiedBy>lenovo</cp:lastModifiedBy>
  <cp:revision>32</cp:revision>
  <dcterms:created xsi:type="dcterms:W3CDTF">2021-02-12T14:53:14Z</dcterms:created>
  <dcterms:modified xsi:type="dcterms:W3CDTF">2022-01-17T09:23:28Z</dcterms:modified>
</cp:coreProperties>
</file>